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98922-99E5-49F0-AA4B-583EEBE889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5C5E5-6ADD-4DAC-A3C1-8C984A1194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D9180-0268-42D7-BBDA-1F59222CF4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36BB0-BE92-4362-9E3A-BF64CBD9B1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6EBF6-4809-4609-88B5-FBA1ABA3E3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B8639-0787-451B-914A-06BCE88525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94B0B-4338-495E-83E7-1A152684FE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0C58B-65BA-4687-8EFB-FBBEA39AB7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97A3D-AB4E-4A19-A6CD-EFC8D741D7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F017C4-8C57-43C6-B162-1A6FEEB556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6BA42-F336-4565-8679-67FDAE42F2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77F70-5A61-4484-BD99-42F2F0D5CA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73DFBE-4C7C-4FA9-B27B-9766C2C78AD3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11280" y="692280"/>
          <a:ext cx="7993080" cy="5726160"/>
        </p:xfrm>
        <a:graphic>
          <a:graphicData uri="http://schemas.openxmlformats.org/drawingml/2006/table">
            <a:tbl>
              <a:tblPr/>
              <a:tblGrid>
                <a:gridCol w="504720"/>
                <a:gridCol w="1008000"/>
                <a:gridCol w="6480360"/>
              </a:tblGrid>
              <a:tr h="27468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. 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ene/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imer name and sequence (5’ to 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892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ST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r: AGCGACTGAGAAGAGAAAACC                Rev: TGTTCAAGCGAAAAGCCG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344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ISP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r: AGAAAAAGTGCTCCTGGGACT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                    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v: TGCTGCCTAAGAACGAG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112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RNA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GACACCTTGGATCCGACCGACATTGTTTGTTGGCGTTTTAGAGCTAGAAATAGCA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984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RNA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TCTAGCTCTAAAACTGGGTCCATGGTCAATCAACCGGTGTTTCGTCCTTTC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464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R KpN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r: CGGGGTACCCTGTTGGCCTTGATGGTGA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v: CGGGGTACCGTTTTCAGCTGGCTCCAGTCT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644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6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R BamH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r: CGCGGATCCCTCCAGCCTCTTAACCAGCCCAG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ev:  CGCGGATCCGATCTGCTTACGCAGGTTAA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856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7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E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r: GATTGGCATGCTACAGGCTG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                    </a:t>
                      </a: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 Rev: AAAAACATGAGGAACAG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8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CTGTGGTGACGAGCA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9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ACAGTGTCTGAGGCTG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CACCGGAGCGATCGCAGA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1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GTGAAC AGTGAGTGGCAC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GATTACAGGCATGAGC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3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CAGCTGGCACGACAGGTT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3680"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4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APD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0240" rIns="3024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r: GAAGGTGAAGGTCGGAGTCAAC           Rev: TGGAAGATGGTGATGGGAT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0240" marR="30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4-20T06:17:15Z</dcterms:created>
  <dc:creator>PG LAB</dc:creator>
  <dc:description/>
  <dc:language>en-US</dc:language>
  <cp:lastModifiedBy>PG LAB</cp:lastModifiedBy>
  <dcterms:modified xsi:type="dcterms:W3CDTF">2017-08-09T06:39:38Z</dcterms:modified>
  <cp:revision>5</cp:revision>
  <dc:subject/>
  <dc:title>Slide 1</dc:title>
</cp:coreProperties>
</file>